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6" d="100"/>
          <a:sy n="76" d="100"/>
        </p:scale>
        <p:origin x="-960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1C3C6-7DB9-3142-86E2-CBE18CB0A62F}" type="datetimeFigureOut">
              <a:rPr lang="en-US" smtClean="0"/>
              <a:t>12/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CCEE-654D-F743-9004-A048015ECB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26341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1C3C6-7DB9-3142-86E2-CBE18CB0A62F}" type="datetimeFigureOut">
              <a:rPr lang="en-US" smtClean="0"/>
              <a:t>12/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CCEE-654D-F743-9004-A048015ECB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4047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1C3C6-7DB9-3142-86E2-CBE18CB0A62F}" type="datetimeFigureOut">
              <a:rPr lang="en-US" smtClean="0"/>
              <a:t>12/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CCEE-654D-F743-9004-A048015ECB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224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1C3C6-7DB9-3142-86E2-CBE18CB0A62F}" type="datetimeFigureOut">
              <a:rPr lang="en-US" smtClean="0"/>
              <a:t>12/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CCEE-654D-F743-9004-A048015ECB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2443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1C3C6-7DB9-3142-86E2-CBE18CB0A62F}" type="datetimeFigureOut">
              <a:rPr lang="en-US" smtClean="0"/>
              <a:t>12/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CCEE-654D-F743-9004-A048015ECB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80893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1C3C6-7DB9-3142-86E2-CBE18CB0A62F}" type="datetimeFigureOut">
              <a:rPr lang="en-US" smtClean="0"/>
              <a:t>12/4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CCEE-654D-F743-9004-A048015ECB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0729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1C3C6-7DB9-3142-86E2-CBE18CB0A62F}" type="datetimeFigureOut">
              <a:rPr lang="en-US" smtClean="0"/>
              <a:t>12/4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CCEE-654D-F743-9004-A048015ECB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8614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1C3C6-7DB9-3142-86E2-CBE18CB0A62F}" type="datetimeFigureOut">
              <a:rPr lang="en-US" smtClean="0"/>
              <a:t>12/4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CCEE-654D-F743-9004-A048015ECB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9847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1C3C6-7DB9-3142-86E2-CBE18CB0A62F}" type="datetimeFigureOut">
              <a:rPr lang="en-US" smtClean="0"/>
              <a:t>12/4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CCEE-654D-F743-9004-A048015ECB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81487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1C3C6-7DB9-3142-86E2-CBE18CB0A62F}" type="datetimeFigureOut">
              <a:rPr lang="en-US" smtClean="0"/>
              <a:t>12/4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CCEE-654D-F743-9004-A048015ECB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98660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1C3C6-7DB9-3142-86E2-CBE18CB0A62F}" type="datetimeFigureOut">
              <a:rPr lang="en-US" smtClean="0"/>
              <a:t>12/4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CCEE-654D-F743-9004-A048015ECB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2928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E1C3C6-7DB9-3142-86E2-CBE18CB0A62F}" type="datetimeFigureOut">
              <a:rPr lang="en-US" smtClean="0"/>
              <a:t>12/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2DCCEE-654D-F743-9004-A048015ECB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490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5" name="Rectangle 4"/>
          <p:cNvSpPr>
            <a:spLocks noChangeArrowheads="1"/>
          </p:cNvSpPr>
          <p:nvPr/>
        </p:nvSpPr>
        <p:spPr bwMode="auto">
          <a:xfrm>
            <a:off x="2930525" y="3317875"/>
            <a:ext cx="355600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b="1">
                <a:solidFill>
                  <a:srgbClr val="0070C0"/>
                </a:solidFill>
              </a:rPr>
              <a:t>CLPB (chr11:72006947-72006764 )</a:t>
            </a:r>
          </a:p>
        </p:txBody>
      </p:sp>
      <p:sp>
        <p:nvSpPr>
          <p:cNvPr id="3076" name="Rectangle 5"/>
          <p:cNvSpPr>
            <a:spLocks noChangeArrowheads="1"/>
          </p:cNvSpPr>
          <p:nvPr/>
        </p:nvSpPr>
        <p:spPr bwMode="auto">
          <a:xfrm>
            <a:off x="2754313" y="5570538"/>
            <a:ext cx="390842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b="1">
                <a:solidFill>
                  <a:srgbClr val="FF0000"/>
                </a:solidFill>
              </a:rPr>
              <a:t>NADSYN1 (chr11:71181090-71181285)</a:t>
            </a:r>
          </a:p>
        </p:txBody>
      </p:sp>
      <p:grpSp>
        <p:nvGrpSpPr>
          <p:cNvPr id="3077" name="Group 24"/>
          <p:cNvGrpSpPr>
            <a:grpSpLocks/>
          </p:cNvGrpSpPr>
          <p:nvPr/>
        </p:nvGrpSpPr>
        <p:grpSpPr bwMode="auto">
          <a:xfrm>
            <a:off x="1744663" y="1135063"/>
            <a:ext cx="5927725" cy="1411287"/>
            <a:chOff x="1787525" y="1962090"/>
            <a:chExt cx="5928416" cy="1411348"/>
          </a:xfrm>
        </p:grpSpPr>
        <p:cxnSp>
          <p:nvCxnSpPr>
            <p:cNvPr id="9" name="Straight Connector 8"/>
            <p:cNvCxnSpPr/>
            <p:nvPr/>
          </p:nvCxnSpPr>
          <p:spPr bwMode="auto">
            <a:xfrm>
              <a:off x="2897316" y="3068625"/>
              <a:ext cx="2818141" cy="0"/>
            </a:xfrm>
            <a:prstGeom prst="line">
              <a:avLst/>
            </a:prstGeom>
            <a:ln w="3810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Right Arrow 9"/>
            <p:cNvSpPr/>
            <p:nvPr/>
          </p:nvSpPr>
          <p:spPr bwMode="auto">
            <a:xfrm>
              <a:off x="2363854" y="2763812"/>
              <a:ext cx="533462" cy="609626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>
                <a:solidFill>
                  <a:srgbClr val="00B050"/>
                </a:solidFill>
              </a:endParaRPr>
            </a:p>
          </p:txBody>
        </p:sp>
        <p:sp>
          <p:nvSpPr>
            <p:cNvPr id="11" name="Right Arrow 10"/>
            <p:cNvSpPr/>
            <p:nvPr/>
          </p:nvSpPr>
          <p:spPr bwMode="auto">
            <a:xfrm>
              <a:off x="6479134" y="2763812"/>
              <a:ext cx="533462" cy="609626"/>
            </a:xfrm>
            <a:prstGeom prst="rightArrow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/>
            </a:p>
          </p:txBody>
        </p:sp>
        <p:cxnSp>
          <p:nvCxnSpPr>
            <p:cNvPr id="12" name="Straight Connector 11"/>
            <p:cNvCxnSpPr/>
            <p:nvPr/>
          </p:nvCxnSpPr>
          <p:spPr bwMode="auto">
            <a:xfrm flipV="1">
              <a:off x="5715458" y="3059099"/>
              <a:ext cx="763676" cy="9525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85" name="TextBox 16"/>
            <p:cNvSpPr txBox="1">
              <a:spLocks noChangeArrowheads="1"/>
            </p:cNvSpPr>
            <p:nvPr/>
          </p:nvSpPr>
          <p:spPr bwMode="auto">
            <a:xfrm>
              <a:off x="5853443" y="2362200"/>
              <a:ext cx="186249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b="1">
                  <a:solidFill>
                    <a:srgbClr val="FF0000"/>
                  </a:solidFill>
                </a:rPr>
                <a:t>NADSYN1: exon 6</a:t>
              </a:r>
            </a:p>
          </p:txBody>
        </p:sp>
        <p:sp>
          <p:nvSpPr>
            <p:cNvPr id="3086" name="TextBox 17"/>
            <p:cNvSpPr txBox="1">
              <a:spLocks noChangeArrowheads="1"/>
            </p:cNvSpPr>
            <p:nvPr/>
          </p:nvSpPr>
          <p:spPr bwMode="auto">
            <a:xfrm>
              <a:off x="1787525" y="2362200"/>
              <a:ext cx="1520673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b="1" dirty="0">
                  <a:solidFill>
                    <a:srgbClr val="0070C0"/>
                  </a:solidFill>
                </a:rPr>
                <a:t>CLPB: exon 12</a:t>
              </a:r>
            </a:p>
          </p:txBody>
        </p:sp>
        <p:sp>
          <p:nvSpPr>
            <p:cNvPr id="3087" name="TextBox 20"/>
            <p:cNvSpPr txBox="1">
              <a:spLocks noChangeArrowheads="1"/>
            </p:cNvSpPr>
            <p:nvPr/>
          </p:nvSpPr>
          <p:spPr bwMode="auto">
            <a:xfrm>
              <a:off x="4202113" y="1962090"/>
              <a:ext cx="867545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2000" b="1"/>
                <a:t>Chr 11</a:t>
              </a:r>
            </a:p>
          </p:txBody>
        </p:sp>
      </p:grpSp>
      <p:cxnSp>
        <p:nvCxnSpPr>
          <p:cNvPr id="16" name="Straight Connector 15"/>
          <p:cNvCxnSpPr/>
          <p:nvPr/>
        </p:nvCxnSpPr>
        <p:spPr>
          <a:xfrm flipH="1">
            <a:off x="455613" y="2241550"/>
            <a:ext cx="5216525" cy="14811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5672138" y="2241550"/>
            <a:ext cx="2938462" cy="14462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80" name="Rectangle 23"/>
          <p:cNvSpPr>
            <a:spLocks noChangeArrowheads="1"/>
          </p:cNvSpPr>
          <p:nvPr/>
        </p:nvSpPr>
        <p:spPr bwMode="auto">
          <a:xfrm>
            <a:off x="325438" y="3733800"/>
            <a:ext cx="8534400" cy="1754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just"/>
            <a:r>
              <a:rPr lang="en-US" b="1" dirty="0">
                <a:solidFill>
                  <a:srgbClr val="0070C0"/>
                </a:solidFill>
              </a:rPr>
              <a:t>ATGCCAGAGAGCAACTGCAGCCTCACCTGGAGGCACTCAGTAGGGAGAGCAGTTGCAGCGCAGGGCGGTGAGCACAGCAGCCAAGGTGCAAGTCTAGTGCTCGGAGAACCCAGAGGAGGAAGCAGCTGGCTGCTGGGGCTGGAGGGAGACACAGGGCTCTGGGGAGGCCTCCTGAAGGAGGTGA</a:t>
            </a:r>
            <a:r>
              <a:rPr lang="en-US" b="1" dirty="0">
                <a:solidFill>
                  <a:srgbClr val="FF0000"/>
                </a:solidFill>
              </a:rPr>
              <a:t>GCTGGGGAGGCCTCACAATCACGGCAGAAGGCGAAAGCCATGTCTTACATAGCGGCAGACAAGAGAGAATGAGAGCCAAGCAAAAAGGGAAACCCATTGTAAAAGCATCAAATCTCCTAAGGCTTACTGCCATGAGAACAGTATGGGGGAACCTGCCCCATGATTCAATTATCTCCCACCGGGTCCCTCCCACAAC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4614435" y="1873875"/>
            <a:ext cx="15968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fused intron</a:t>
            </a:r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381000" y="304800"/>
            <a:ext cx="1172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 smtClean="0"/>
              <a:t>S9</a:t>
            </a:r>
            <a:r>
              <a:rPr lang="en-US" dirty="0" smtClean="0"/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351551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8</TotalTime>
  <Words>31</Words>
  <Application>Microsoft Macintosh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w</dc:creator>
  <cp:lastModifiedBy>Dan Li</cp:lastModifiedBy>
  <cp:revision>92</cp:revision>
  <dcterms:created xsi:type="dcterms:W3CDTF">2014-03-27T02:16:47Z</dcterms:created>
  <dcterms:modified xsi:type="dcterms:W3CDTF">2015-12-05T01:04:20Z</dcterms:modified>
</cp:coreProperties>
</file>